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1" d="100"/>
          <a:sy n="91" d="100"/>
        </p:scale>
        <p:origin x="351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D79414-4D2F-17AE-BDF1-7655CFC9D1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1E550D6-2767-F5DF-8E8B-88E3C3ECAA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E1D6829-B724-50E5-E872-2897D36545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AAE85-9D71-44E7-8ED5-70F953715E64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1C047E9-9B02-D386-899D-4BF159014E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FC4F82A-6C2E-AE5C-D77C-C80AD68E8B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3612E-EEC3-40F0-B9C9-B7E1EC01EC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516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78E5EC2-D339-E1EA-72B2-C766E0E78E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56985AB-8778-3FAF-6758-96DE8DC737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E893AF9-0735-85F2-B342-D57B5957E5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AAE85-9D71-44E7-8ED5-70F953715E64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62106FE-1B60-8687-5AA8-D10C195E3B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C9790F8-0011-284A-E73E-98E4C6E90C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3612E-EEC3-40F0-B9C9-B7E1EC01EC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09181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FB67EEB-9704-E455-D1C0-F86D5F5F2E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EF4657D-D2C0-FD77-B71D-68F70FC508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8E311CA-79C3-605C-A4EE-12FBDA9DD5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AAE85-9D71-44E7-8ED5-70F953715E64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104209-C6D4-95EE-2B68-E5283F1316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664F83C-7DDF-1A05-12B5-0C0FEB507A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3612E-EEC3-40F0-B9C9-B7E1EC01EC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968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E62F0DF-782A-BEE3-C1F5-EE9952B5A8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DF0A2E0-F5F7-6525-008C-5A3D7AFE18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F5826E8-C917-49A0-5434-221EE674F4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AAE85-9D71-44E7-8ED5-70F953715E64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7A69B15-3D65-520F-57B3-3A25355A88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C6B7DC9-0BA9-D711-4D1F-12D0A17394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3612E-EEC3-40F0-B9C9-B7E1EC01EC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75724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3EC74A-87EB-1645-D23B-0DC0D8A081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4D4E1E4-0D4C-146E-3B33-7BBD37DC47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B54ADCF-5D71-0A10-867B-9FE232E378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AAE85-9D71-44E7-8ED5-70F953715E64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23BD30E-D563-FF75-95DC-DCC377DBD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7AE5B83-288F-4520-1D09-153B61800F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3612E-EEC3-40F0-B9C9-B7E1EC01EC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12638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B59A1CA-5782-100C-7C63-0B81FBF7F8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9BEAA28-C015-F782-9075-4DCFA267EA0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0E0EF94-C0FC-1E42-78CE-F889A00357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67A54D0-04B1-04A2-573A-35808A0769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AAE85-9D71-44E7-8ED5-70F953715E64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6686F6A-5C34-53E1-5655-8605B0E320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D2AC36D-B31A-8835-7D6C-CFBF7FFAAB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3612E-EEC3-40F0-B9C9-B7E1EC01EC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02508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32965FB-D531-EE1B-C62C-322BD61290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87BC0AC-9FCD-E3FD-DC42-30BF420F0C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80DE416-06F5-BC93-58F3-896547BC4F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C3B12DA-4C99-6CD0-6422-4C5D51EA44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2594087-C557-AA86-1D67-BA9B88CCD36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F4E00BD-2E99-CED2-6BFD-A9D5A9D1A8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AAE85-9D71-44E7-8ED5-70F953715E64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30DB595-E7B5-C175-458F-C53C46855C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C939F96-73F3-95AD-5D6E-DEBA3EC6F9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3612E-EEC3-40F0-B9C9-B7E1EC01EC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0288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29063F-9AB4-4ACB-79F1-B1A0EE2081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7E2C215-4778-761F-099A-20E0613982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AAE85-9D71-44E7-8ED5-70F953715E64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030E76E-49B6-067E-C7A6-0134677838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F311518-DCD5-2C99-06E6-D06BF96F01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3612E-EEC3-40F0-B9C9-B7E1EC01EC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3354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7D859B5-51C8-2CE0-8290-B081766812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AAE85-9D71-44E7-8ED5-70F953715E64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918A506-59AF-5D6E-0A25-6C75E1F389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B1E7B71-D955-19C5-1C3B-FC2353C9D6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3612E-EEC3-40F0-B9C9-B7E1EC01EC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0856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06E589B-C9FF-0911-72BC-F4CA3337AB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A7D8E30-C81D-89ED-5CF3-0B4360EDE2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A3ED6D6-1176-9B20-8623-0C7F8C5C89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D31BEFF-567D-8DC8-F491-D269272604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AAE85-9D71-44E7-8ED5-70F953715E64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F069802-F68E-F82C-6805-534F6B0FDE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C9963F8-7539-1056-C539-356D2E336E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3612E-EEC3-40F0-B9C9-B7E1EC01EC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62904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25EF136-A56A-4BC0-0FC9-36976A31DD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F4323C4-9F03-4614-6527-72C5229475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84FE5B6-434A-8E1D-D7C4-F32B31C684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CA0A5CE-46A3-0466-A946-0F1447A9CF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AAE85-9D71-44E7-8ED5-70F953715E64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06E5A9B-80B3-E3C4-A731-65C05E26C0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7DD531B-083D-FAE9-1667-1FC91BD612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3612E-EEC3-40F0-B9C9-B7E1EC01EC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58526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F5CB9BA-5215-1F7B-F346-67A825402A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282A44E-0F29-B3C1-3BCD-88FDB6DB13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2C72C2C-3F8A-2087-A085-54715A829E0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CAAE85-9D71-44E7-8ED5-70F953715E64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624AD75-6FFF-6A3F-3E67-DD4F022824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11B859-E87B-7EB5-2ABD-DCF393653F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33612E-EEC3-40F0-B9C9-B7E1EC01EC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06512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CA59DAD3-20B9-EA6F-1195-4EEF2A75375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60631238"/>
              </p:ext>
            </p:extLst>
          </p:nvPr>
        </p:nvGraphicFramePr>
        <p:xfrm>
          <a:off x="3267535" y="1619646"/>
          <a:ext cx="5656930" cy="2963226"/>
        </p:xfrm>
        <a:graphic>
          <a:graphicData uri="http://schemas.openxmlformats.org/drawingml/2006/table">
            <a:tbl>
              <a:tblPr firstRow="1" firstCol="1" bandRow="1"/>
              <a:tblGrid>
                <a:gridCol w="2057757">
                  <a:extLst>
                    <a:ext uri="{9D8B030D-6E8A-4147-A177-3AD203B41FA5}">
                      <a16:colId xmlns:a16="http://schemas.microsoft.com/office/drawing/2014/main" val="3875351102"/>
                    </a:ext>
                  </a:extLst>
                </a:gridCol>
                <a:gridCol w="1470221">
                  <a:extLst>
                    <a:ext uri="{9D8B030D-6E8A-4147-A177-3AD203B41FA5}">
                      <a16:colId xmlns:a16="http://schemas.microsoft.com/office/drawing/2014/main" val="3112048095"/>
                    </a:ext>
                  </a:extLst>
                </a:gridCol>
                <a:gridCol w="1470221">
                  <a:extLst>
                    <a:ext uri="{9D8B030D-6E8A-4147-A177-3AD203B41FA5}">
                      <a16:colId xmlns:a16="http://schemas.microsoft.com/office/drawing/2014/main" val="3652954006"/>
                    </a:ext>
                  </a:extLst>
                </a:gridCol>
                <a:gridCol w="658731">
                  <a:extLst>
                    <a:ext uri="{9D8B030D-6E8A-4147-A177-3AD203B41FA5}">
                      <a16:colId xmlns:a16="http://schemas.microsoft.com/office/drawing/2014/main" val="2383061276"/>
                    </a:ext>
                  </a:extLst>
                </a:gridCol>
              </a:tblGrid>
              <a:tr h="491201">
                <a:tc rowSpan="2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trains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MICs</a:t>
                      </a:r>
                      <a:r>
                        <a:rPr lang="zh-CN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μg/mL</a:t>
                      </a:r>
                      <a:r>
                        <a:rPr lang="zh-CN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）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69557419"/>
                  </a:ext>
                </a:extLst>
              </a:tr>
              <a:tr h="49440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MP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MC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EP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0912850"/>
                  </a:ext>
                </a:extLst>
              </a:tr>
              <a:tr h="49440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E. coli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1917</a:t>
                      </a: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Δ</a:t>
                      </a:r>
                      <a:r>
                        <a:rPr lang="en-US" sz="12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sd</a:t>
                      </a: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/I2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8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44936213"/>
                  </a:ext>
                </a:extLst>
              </a:tr>
              <a:tr h="49440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E. coli</a:t>
                      </a: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C600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8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2003545"/>
                  </a:ext>
                </a:extLst>
              </a:tr>
              <a:tr h="49440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E. coli</a:t>
                      </a: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SMS27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56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2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56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753923"/>
                  </a:ext>
                </a:extLst>
              </a:tr>
              <a:tr h="49440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K. pneumoniae</a:t>
                      </a: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700603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&gt;256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2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28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44122911"/>
                  </a:ext>
                </a:extLst>
              </a:tr>
            </a:tbl>
          </a:graphicData>
        </a:graphic>
      </p:graphicFrame>
      <p:sp>
        <p:nvSpPr>
          <p:cNvPr id="4" name="文本框 3">
            <a:extLst>
              <a:ext uri="{FF2B5EF4-FFF2-40B4-BE49-F238E27FC236}">
                <a16:creationId xmlns:a16="http://schemas.microsoft.com/office/drawing/2014/main" id="{2DDC1077-9375-C230-53CB-B64573F7EA2A}"/>
              </a:ext>
            </a:extLst>
          </p:cNvPr>
          <p:cNvSpPr txBox="1"/>
          <p:nvPr/>
        </p:nvSpPr>
        <p:spPr>
          <a:xfrm>
            <a:off x="3410606" y="4582872"/>
            <a:ext cx="5039711" cy="4090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2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MP: ampicillin; AMC: amoxicillin/clavulanic acid; CEP: cephalexin.</a:t>
            </a:r>
            <a:endParaRPr lang="zh-CN" altLang="zh-CN" sz="1200" kern="100" dirty="0">
              <a:effectLst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30275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6</Words>
  <Application>Microsoft Office PowerPoint</Application>
  <PresentationFormat>宽屏</PresentationFormat>
  <Paragraphs>2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Kaidi Liu</dc:creator>
  <cp:lastModifiedBy>Kaidi Liu</cp:lastModifiedBy>
  <cp:revision>4</cp:revision>
  <dcterms:created xsi:type="dcterms:W3CDTF">2024-02-22T07:49:48Z</dcterms:created>
  <dcterms:modified xsi:type="dcterms:W3CDTF">2024-02-22T08:04:23Z</dcterms:modified>
</cp:coreProperties>
</file>